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8" r:id="rId4"/>
    <p:sldId id="259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048291113968634"/>
          <c:y val="0.1605696589267859"/>
          <c:w val="0.85627395013123364"/>
          <c:h val="0.689982037401574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oglio1!$B$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7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A$2:$A$7</c:f>
              <c:strCache>
                <c:ptCount val="6"/>
                <c:pt idx="0">
                  <c:v>RUNX2 3 d</c:v>
                </c:pt>
                <c:pt idx="1">
                  <c:v>RUNX2 7 d</c:v>
                </c:pt>
                <c:pt idx="2">
                  <c:v>RUNX2 14 d</c:v>
                </c:pt>
                <c:pt idx="3">
                  <c:v>SP7 3 d</c:v>
                </c:pt>
                <c:pt idx="4">
                  <c:v>SP7 7 d</c:v>
                </c:pt>
                <c:pt idx="5">
                  <c:v>SP7 14 d</c:v>
                </c:pt>
              </c:strCache>
            </c:strRef>
          </c:cat>
          <c:val>
            <c:numRef>
              <c:f>Foglio1!$B$2:$B$7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C5-435B-9FD1-55DED2447FEB}"/>
            </c:ext>
          </c:extLst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0.625 micr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1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A$2:$A$7</c:f>
              <c:strCache>
                <c:ptCount val="6"/>
                <c:pt idx="0">
                  <c:v>RUNX2 3 d</c:v>
                </c:pt>
                <c:pt idx="1">
                  <c:v>RUNX2 7 d</c:v>
                </c:pt>
                <c:pt idx="2">
                  <c:v>RUNX2 14 d</c:v>
                </c:pt>
                <c:pt idx="3">
                  <c:v>SP7 3 d</c:v>
                </c:pt>
                <c:pt idx="4">
                  <c:v>SP7 7 d</c:v>
                </c:pt>
                <c:pt idx="5">
                  <c:v>SP7 14 d</c:v>
                </c:pt>
              </c:strCache>
            </c:strRef>
          </c:cat>
          <c:val>
            <c:numRef>
              <c:f>Foglio1!$C$2:$C$7</c:f>
              <c:numCache>
                <c:formatCode>General</c:formatCode>
                <c:ptCount val="6"/>
                <c:pt idx="0">
                  <c:v>0.7</c:v>
                </c:pt>
                <c:pt idx="1">
                  <c:v>1.3</c:v>
                </c:pt>
                <c:pt idx="2">
                  <c:v>0.92</c:v>
                </c:pt>
                <c:pt idx="3">
                  <c:v>1.8</c:v>
                </c:pt>
                <c:pt idx="4">
                  <c:v>1.42</c:v>
                </c:pt>
                <c:pt idx="5">
                  <c:v>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C5-435B-9FD1-55DED2447FEB}"/>
            </c:ext>
          </c:extLst>
        </c:ser>
        <c:ser>
          <c:idx val="2"/>
          <c:order val="2"/>
          <c:tx>
            <c:strRef>
              <c:f>Foglio1!$D$1</c:f>
              <c:strCache>
                <c:ptCount val="1"/>
                <c:pt idx="0">
                  <c:v>1.25 micr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1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A$2:$A$7</c:f>
              <c:strCache>
                <c:ptCount val="6"/>
                <c:pt idx="0">
                  <c:v>RUNX2 3 d</c:v>
                </c:pt>
                <c:pt idx="1">
                  <c:v>RUNX2 7 d</c:v>
                </c:pt>
                <c:pt idx="2">
                  <c:v>RUNX2 14 d</c:v>
                </c:pt>
                <c:pt idx="3">
                  <c:v>SP7 3 d</c:v>
                </c:pt>
                <c:pt idx="4">
                  <c:v>SP7 7 d</c:v>
                </c:pt>
                <c:pt idx="5">
                  <c:v>SP7 14 d</c:v>
                </c:pt>
              </c:strCache>
            </c:strRef>
          </c:cat>
          <c:val>
            <c:numRef>
              <c:f>Foglio1!$D$2:$D$7</c:f>
              <c:numCache>
                <c:formatCode>General</c:formatCode>
                <c:ptCount val="6"/>
                <c:pt idx="0">
                  <c:v>0.92</c:v>
                </c:pt>
                <c:pt idx="1">
                  <c:v>1.37</c:v>
                </c:pt>
                <c:pt idx="2">
                  <c:v>1.1000000000000001</c:v>
                </c:pt>
                <c:pt idx="3">
                  <c:v>1.82</c:v>
                </c:pt>
                <c:pt idx="4">
                  <c:v>1.56</c:v>
                </c:pt>
                <c:pt idx="5">
                  <c:v>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5C5-435B-9FD1-55DED2447FEB}"/>
            </c:ext>
          </c:extLst>
        </c:ser>
        <c:ser>
          <c:idx val="3"/>
          <c:order val="3"/>
          <c:tx>
            <c:strRef>
              <c:f>Foglio1!$E$1</c:f>
              <c:strCache>
                <c:ptCount val="1"/>
                <c:pt idx="0">
                  <c:v>2.5 micr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14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A$2:$A$7</c:f>
              <c:strCache>
                <c:ptCount val="6"/>
                <c:pt idx="0">
                  <c:v>RUNX2 3 d</c:v>
                </c:pt>
                <c:pt idx="1">
                  <c:v>RUNX2 7 d</c:v>
                </c:pt>
                <c:pt idx="2">
                  <c:v>RUNX2 14 d</c:v>
                </c:pt>
                <c:pt idx="3">
                  <c:v>SP7 3 d</c:v>
                </c:pt>
                <c:pt idx="4">
                  <c:v>SP7 7 d</c:v>
                </c:pt>
                <c:pt idx="5">
                  <c:v>SP7 14 d</c:v>
                </c:pt>
              </c:strCache>
            </c:strRef>
          </c:cat>
          <c:val>
            <c:numRef>
              <c:f>Foglio1!$E$2:$E$7</c:f>
              <c:numCache>
                <c:formatCode>General</c:formatCode>
                <c:ptCount val="6"/>
                <c:pt idx="0">
                  <c:v>1.48</c:v>
                </c:pt>
                <c:pt idx="1">
                  <c:v>2.9</c:v>
                </c:pt>
                <c:pt idx="2">
                  <c:v>1.3</c:v>
                </c:pt>
                <c:pt idx="3">
                  <c:v>3.2</c:v>
                </c:pt>
                <c:pt idx="4">
                  <c:v>1.8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5C5-435B-9FD1-55DED2447FEB}"/>
            </c:ext>
          </c:extLst>
        </c:ser>
        <c:ser>
          <c:idx val="4"/>
          <c:order val="4"/>
          <c:tx>
            <c:strRef>
              <c:f>Foglio1!$F$1</c:f>
              <c:strCache>
                <c:ptCount val="1"/>
                <c:pt idx="0">
                  <c:v>5 micr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8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A$2:$A$7</c:f>
              <c:strCache>
                <c:ptCount val="6"/>
                <c:pt idx="0">
                  <c:v>RUNX2 3 d</c:v>
                </c:pt>
                <c:pt idx="1">
                  <c:v>RUNX2 7 d</c:v>
                </c:pt>
                <c:pt idx="2">
                  <c:v>RUNX2 14 d</c:v>
                </c:pt>
                <c:pt idx="3">
                  <c:v>SP7 3 d</c:v>
                </c:pt>
                <c:pt idx="4">
                  <c:v>SP7 7 d</c:v>
                </c:pt>
                <c:pt idx="5">
                  <c:v>SP7 14 d</c:v>
                </c:pt>
              </c:strCache>
            </c:strRef>
          </c:cat>
          <c:val>
            <c:numRef>
              <c:f>Foglio1!$F$2:$F$7</c:f>
              <c:numCache>
                <c:formatCode>General</c:formatCode>
                <c:ptCount val="6"/>
                <c:pt idx="0">
                  <c:v>0.9</c:v>
                </c:pt>
                <c:pt idx="1">
                  <c:v>1.38</c:v>
                </c:pt>
                <c:pt idx="2">
                  <c:v>1</c:v>
                </c:pt>
                <c:pt idx="3">
                  <c:v>1.38</c:v>
                </c:pt>
                <c:pt idx="4">
                  <c:v>0.84</c:v>
                </c:pt>
                <c:pt idx="5">
                  <c:v>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5C5-435B-9FD1-55DED2447F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3765056"/>
        <c:axId val="293765384"/>
      </c:barChart>
      <c:catAx>
        <c:axId val="29376505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93765384"/>
        <c:crosses val="autoZero"/>
        <c:auto val="1"/>
        <c:lblAlgn val="ctr"/>
        <c:lblOffset val="100"/>
        <c:noMultiLvlLbl val="0"/>
      </c:catAx>
      <c:valAx>
        <c:axId val="2937653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200" b="1" i="1" dirty="0" err="1"/>
                  <a:t>Fold</a:t>
                </a:r>
                <a:r>
                  <a:rPr lang="it-IT" sz="1200" b="1" i="1" baseline="0" dirty="0"/>
                  <a:t> of gene </a:t>
                </a:r>
                <a:r>
                  <a:rPr lang="it-IT" sz="1200" b="1" i="1" baseline="0" dirty="0" err="1"/>
                  <a:t>expression</a:t>
                </a:r>
                <a:r>
                  <a:rPr lang="it-IT" sz="1200" b="1" i="1" baseline="0" dirty="0"/>
                  <a:t> </a:t>
                </a:r>
                <a:endParaRPr lang="en-GB" sz="1200" b="1" i="1" dirty="0"/>
              </a:p>
            </c:rich>
          </c:tx>
          <c:layout>
            <c:manualLayout>
              <c:xMode val="edge"/>
              <c:yMode val="edge"/>
              <c:x val="1.1438991844394829E-2"/>
              <c:y val="0.2995490754438590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937650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343370938582581"/>
          <c:y val="0.92634265127004034"/>
          <c:w val="0.59313258122834833"/>
          <c:h val="7.365734872995971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A6966-A69E-4E30-94DB-52BBC22EE7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47F46A-871D-4709-B636-AB434E06CF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E8B518-9568-4473-9C3C-DD33D9644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8750B4-F775-4186-88C8-40A9F3753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25E07D-E8EB-424F-BEB4-DF0AF3EB0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9629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745C25-C2C0-412A-A48D-1116DA485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D0E371-D83F-45A7-AD59-475500C725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CE6B6-5021-4657-81FD-2B1327A82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2E7D60-DD65-43E5-B559-322C35BC2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1982B9-98E4-4629-8177-7D594B074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6053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EB9B4E-DD9C-4322-A034-BD297E05AC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8E6812-538B-419A-8CA6-8EDE0890BC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103DD6-DD91-4296-9C43-522368760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D9AACE-2E82-4ECB-9B1E-8A19567A2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C44B2-E8D5-4997-80C2-029DCB682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0582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CEA714-22F2-4ADE-A15C-E8772B470F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72B08D-D50C-4466-9835-BDBE84B7AB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4FED2C-15A3-4333-8958-9428E47FD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A119AA-0EC0-4BB4-ABF9-4B558C3DA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730F75-D40E-4988-A225-B4B56BBBC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9942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BF190-F247-4D5D-8796-7C380E1CFC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5A229B-B644-4DB2-9A17-43993A21A3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276106-639B-44F9-9D03-AB51951BA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99891C-7522-4B51-BC3A-24EFA4FFB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24F9C7-BBA7-4283-B762-B92D98A40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2117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9C9180-5908-423F-BDA0-9297B2B6E8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660A4A-8FF9-4580-9793-D6B6757595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7B4774-B672-405C-9EC3-5B2F88CBAF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FF6EB5-5182-4D7C-932C-C424961E1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D150AD-8CE5-4A41-A64B-73F9F6276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1BA2B4-1BEF-49D9-A130-4FEE7DE19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480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4FBE5D-C076-4251-B0E5-8AE8C2DBF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EEECC8-FB54-4499-8D6D-02007A7D48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C3602E-0FC6-4BA8-AC39-14A14DDDBB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1CFB62-2597-4DAC-83AF-D2AD36716F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42C410-D88E-4CBA-BAF2-928E6FDC92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2CF9FC-F86C-497D-BF4E-5BA34C4C7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378670-427E-4A25-83C9-60C2C064F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DA9F91-2B86-42D8-9D2B-5B8232F56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5034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CE440-DB90-48E5-B84D-8BB7334967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AF6447D-DB92-428B-B2BD-89B99F538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98A883D-AB6C-4404-933C-C15B53F1C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29F7FD-0687-40FA-B32E-1A467537F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4930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D104F9-6F14-4759-A9ED-5144DE219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C998EA-4286-495B-A765-3412FC7DF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554F40-CA31-4625-9DB4-A1F2171AE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8786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EA143-E7C6-4B91-AE92-E6B9582A6C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776718-2CE3-4CB4-BF73-3C0C178C8D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34DE20-9B0D-4D77-BF77-C1413840DD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D72B96-445C-448A-86FD-3C80EFC96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363B9F-36B9-45E5-BDBF-13ACC0B49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3A2242-E430-42E1-BF27-99A4D056A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7308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14124-34CB-4759-9E1F-3044EF069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EB527C-5C4B-4EC8-B02F-633B78C363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436D6C-FADC-4FA9-BA4A-EC599FD418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4431ED-C72C-4548-966A-AFA3BCE70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F58638-7DC5-4AC9-856D-3C239A908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67A1DC-C1D0-4E76-97D6-FD29E592D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9700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07210D-556C-4B76-AE68-29F1F38A8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8FAAE5-5F11-48FE-BD77-ADFFDAE693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296A3-6A5F-42EA-87D5-3E7D50B1DC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60B1D-DA94-4937-A2BC-634B92D9761D}" type="datetimeFigureOut">
              <a:rPr lang="it-IT" smtClean="0"/>
              <a:t>28/02/2022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E89815-2B29-422D-9ADF-72D2A5D21D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3BA0F3-0492-4310-8568-AB9F6D3FAA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34FEC-5452-4A64-857B-AF428ECA641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8180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>
            <a:extLst>
              <a:ext uri="{FF2B5EF4-FFF2-40B4-BE49-F238E27FC236}">
                <a16:creationId xmlns:a16="http://schemas.microsoft.com/office/drawing/2014/main" id="{8B49A9A0-10CD-44C3-9232-19E073442265}"/>
              </a:ext>
            </a:extLst>
          </p:cNvPr>
          <p:cNvGrpSpPr/>
          <p:nvPr/>
        </p:nvGrpSpPr>
        <p:grpSpPr>
          <a:xfrm>
            <a:off x="2178061" y="984079"/>
            <a:ext cx="7920880" cy="3755608"/>
            <a:chOff x="827584" y="116632"/>
            <a:chExt cx="7272808" cy="3600400"/>
          </a:xfrm>
        </p:grpSpPr>
        <p:graphicFrame>
          <p:nvGraphicFramePr>
            <p:cNvPr id="18" name="Grafico 17">
              <a:extLst>
                <a:ext uri="{FF2B5EF4-FFF2-40B4-BE49-F238E27FC236}">
                  <a16:creationId xmlns:a16="http://schemas.microsoft.com/office/drawing/2014/main" id="{1984656A-2D0B-4FFD-8A36-3EA78ABA107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293163957"/>
                </p:ext>
              </p:extLst>
            </p:nvPr>
          </p:nvGraphicFramePr>
          <p:xfrm>
            <a:off x="827584" y="116632"/>
            <a:ext cx="7272808" cy="360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C72FC4A2-839B-4DD4-90F6-ED7AFAD51804}"/>
                </a:ext>
              </a:extLst>
            </p:cNvPr>
            <p:cNvSpPr txBox="1"/>
            <p:nvPr/>
          </p:nvSpPr>
          <p:spPr>
            <a:xfrm>
              <a:off x="2195736" y="1871699"/>
              <a:ext cx="263755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FC26D04D-2277-4DE4-BA4B-3FFB83BE0A1E}"/>
                </a:ext>
              </a:extLst>
            </p:cNvPr>
            <p:cNvSpPr txBox="1"/>
            <p:nvPr/>
          </p:nvSpPr>
          <p:spPr>
            <a:xfrm>
              <a:off x="3131840" y="836712"/>
              <a:ext cx="357953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*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414B9E8C-95B3-41C5-B9CA-6F1A1776A0C1}"/>
                </a:ext>
              </a:extLst>
            </p:cNvPr>
            <p:cNvSpPr txBox="1"/>
            <p:nvPr/>
          </p:nvSpPr>
          <p:spPr>
            <a:xfrm>
              <a:off x="2891924" y="2056365"/>
              <a:ext cx="263755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E07FE1E8-09AF-49E5-80BF-E7CA9A7014AD}"/>
                </a:ext>
              </a:extLst>
            </p:cNvPr>
            <p:cNvSpPr txBox="1"/>
            <p:nvPr/>
          </p:nvSpPr>
          <p:spPr>
            <a:xfrm>
              <a:off x="3039507" y="1904286"/>
              <a:ext cx="263755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4A596E25-E2B6-4BB9-A57D-5FB2322A8CFE}"/>
                </a:ext>
              </a:extLst>
            </p:cNvPr>
            <p:cNvSpPr txBox="1"/>
            <p:nvPr/>
          </p:nvSpPr>
          <p:spPr>
            <a:xfrm>
              <a:off x="3339589" y="1980326"/>
              <a:ext cx="263755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E13749DE-A04F-4EFD-8B60-5D2C67ABBDC7}"/>
                </a:ext>
              </a:extLst>
            </p:cNvPr>
            <p:cNvSpPr txBox="1"/>
            <p:nvPr/>
          </p:nvSpPr>
          <p:spPr>
            <a:xfrm>
              <a:off x="4260076" y="1970289"/>
              <a:ext cx="263755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6CF34B1D-FD9B-4A80-9D09-12E832D2E6A6}"/>
                </a:ext>
              </a:extLst>
            </p:cNvPr>
            <p:cNvSpPr txBox="1"/>
            <p:nvPr/>
          </p:nvSpPr>
          <p:spPr>
            <a:xfrm>
              <a:off x="5148064" y="652046"/>
              <a:ext cx="452152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**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7BF38299-CB54-4212-A40A-A85B6B8C1A86}"/>
                </a:ext>
              </a:extLst>
            </p:cNvPr>
            <p:cNvSpPr txBox="1"/>
            <p:nvPr/>
          </p:nvSpPr>
          <p:spPr>
            <a:xfrm>
              <a:off x="5056490" y="1542236"/>
              <a:ext cx="357953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*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5BD5D320-61C4-4DAD-B3D1-BD23386FCCE3}"/>
                </a:ext>
              </a:extLst>
            </p:cNvPr>
            <p:cNvSpPr txBox="1"/>
            <p:nvPr/>
          </p:nvSpPr>
          <p:spPr>
            <a:xfrm>
              <a:off x="4848741" y="1687033"/>
              <a:ext cx="357953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*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06C406AF-79B6-49E5-A942-0CCF6771C999}"/>
                </a:ext>
              </a:extLst>
            </p:cNvPr>
            <p:cNvSpPr txBox="1"/>
            <p:nvPr/>
          </p:nvSpPr>
          <p:spPr>
            <a:xfrm>
              <a:off x="5425211" y="1999873"/>
              <a:ext cx="263755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EBE96490-E5E5-4FAD-AC80-944E2F987ED1}"/>
                </a:ext>
              </a:extLst>
            </p:cNvPr>
            <p:cNvSpPr txBox="1"/>
            <p:nvPr/>
          </p:nvSpPr>
          <p:spPr>
            <a:xfrm>
              <a:off x="5979251" y="1972989"/>
              <a:ext cx="263755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3054329E-E34F-48F5-818C-D550860FF8D5}"/>
                </a:ext>
              </a:extLst>
            </p:cNvPr>
            <p:cNvSpPr txBox="1"/>
            <p:nvPr/>
          </p:nvSpPr>
          <p:spPr>
            <a:xfrm>
              <a:off x="6071584" y="1819672"/>
              <a:ext cx="357953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*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023C539A-1E89-4AEA-A3FC-848F20D37D70}"/>
                </a:ext>
              </a:extLst>
            </p:cNvPr>
            <p:cNvSpPr txBox="1"/>
            <p:nvPr/>
          </p:nvSpPr>
          <p:spPr>
            <a:xfrm>
              <a:off x="6253004" y="1664866"/>
              <a:ext cx="357953" cy="3454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**</a:t>
              </a:r>
            </a:p>
          </p:txBody>
        </p:sp>
      </p:grp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751789FD-98E6-4EDF-ACE2-8983B675699F}"/>
              </a:ext>
            </a:extLst>
          </p:cNvPr>
          <p:cNvSpPr txBox="1"/>
          <p:nvPr/>
        </p:nvSpPr>
        <p:spPr>
          <a:xfrm>
            <a:off x="3325186" y="5509117"/>
            <a:ext cx="50490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set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lementation during osteogenic differentiatio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4853813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AFE3A60-3BBD-4341-93A3-60F72B6FD153}"/>
              </a:ext>
            </a:extLst>
          </p:cNvPr>
          <p:cNvSpPr txBox="1"/>
          <p:nvPr/>
        </p:nvSpPr>
        <p:spPr>
          <a:xfrm>
            <a:off x="2263220" y="5766319"/>
            <a:ext cx="7602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M image of single PLGA[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of 129 nm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55143F14-06C6-40B3-950B-9CCBCEE738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3989" y="749945"/>
            <a:ext cx="5024021" cy="4796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44169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4">
            <a:extLst>
              <a:ext uri="{FF2B5EF4-FFF2-40B4-BE49-F238E27FC236}">
                <a16:creationId xmlns:a16="http://schemas.microsoft.com/office/drawing/2014/main" id="{CFFEAE6D-3956-497F-8B17-5851FB24E5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3219" y="358119"/>
            <a:ext cx="8155908" cy="534252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AFE3A60-3BBD-4341-93A3-60F72B6FD153}"/>
              </a:ext>
            </a:extLst>
          </p:cNvPr>
          <p:cNvSpPr txBox="1"/>
          <p:nvPr/>
        </p:nvSpPr>
        <p:spPr>
          <a:xfrm>
            <a:off x="2263219" y="5766319"/>
            <a:ext cx="9051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S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crofluidic system containing human intestinal epithelial tissue to assess the ability of PLGA[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s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 to cross the intestine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9971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AFE3A60-3BBD-4341-93A3-60F72B6FD153}"/>
              </a:ext>
            </a:extLst>
          </p:cNvPr>
          <p:cNvSpPr txBox="1"/>
          <p:nvPr/>
        </p:nvSpPr>
        <p:spPr>
          <a:xfrm>
            <a:off x="2263219" y="5766319"/>
            <a:ext cx="9051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calibration curves in DMSO and Physiological solution for free Fiseti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etivel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FEN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7" name="Gruppo 386">
            <a:extLst>
              <a:ext uri="{FF2B5EF4-FFF2-40B4-BE49-F238E27FC236}">
                <a16:creationId xmlns:a16="http://schemas.microsoft.com/office/drawing/2014/main" id="{B2721A70-EE76-478C-B66D-5B412A70EE03}"/>
              </a:ext>
            </a:extLst>
          </p:cNvPr>
          <p:cNvGrpSpPr/>
          <p:nvPr/>
        </p:nvGrpSpPr>
        <p:grpSpPr>
          <a:xfrm>
            <a:off x="2265540" y="695683"/>
            <a:ext cx="7660920" cy="5066999"/>
            <a:chOff x="2265540" y="595015"/>
            <a:chExt cx="7660920" cy="5066999"/>
          </a:xfrm>
        </p:grpSpPr>
        <p:pic>
          <p:nvPicPr>
            <p:cNvPr id="385" name="Immagine 384">
              <a:extLst>
                <a:ext uri="{FF2B5EF4-FFF2-40B4-BE49-F238E27FC236}">
                  <a16:creationId xmlns:a16="http://schemas.microsoft.com/office/drawing/2014/main" id="{363FC9CE-D3F1-48A7-BB56-3B02305015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50883"/>
            <a:stretch/>
          </p:blipFill>
          <p:spPr>
            <a:xfrm>
              <a:off x="2265540" y="595015"/>
              <a:ext cx="7660920" cy="2433411"/>
            </a:xfrm>
            <a:prstGeom prst="rect">
              <a:avLst/>
            </a:prstGeom>
          </p:spPr>
        </p:pic>
        <p:pic>
          <p:nvPicPr>
            <p:cNvPr id="386" name="Immagine 385">
              <a:extLst>
                <a:ext uri="{FF2B5EF4-FFF2-40B4-BE49-F238E27FC236}">
                  <a16:creationId xmlns:a16="http://schemas.microsoft.com/office/drawing/2014/main" id="{0C4A8445-2DBC-46C6-B793-0F04EC15AA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48948" r="50892"/>
            <a:stretch/>
          </p:blipFill>
          <p:spPr>
            <a:xfrm>
              <a:off x="4214921" y="3132730"/>
              <a:ext cx="3762157" cy="25292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07653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1</Words>
  <Application>Microsoft Office PowerPoint</Application>
  <PresentationFormat>Widescreen</PresentationFormat>
  <Paragraphs>18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Teresa Valenti</dc:creator>
  <cp:lastModifiedBy>maria</cp:lastModifiedBy>
  <cp:revision>5</cp:revision>
  <dcterms:created xsi:type="dcterms:W3CDTF">2021-11-09T09:07:27Z</dcterms:created>
  <dcterms:modified xsi:type="dcterms:W3CDTF">2022-02-28T12:02:15Z</dcterms:modified>
</cp:coreProperties>
</file>